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88" r:id="rId2"/>
    <p:sldId id="277" r:id="rId3"/>
    <p:sldId id="278" r:id="rId4"/>
    <p:sldId id="280" r:id="rId5"/>
    <p:sldId id="282" r:id="rId6"/>
    <p:sldId id="284" r:id="rId7"/>
    <p:sldId id="287" r:id="rId8"/>
    <p:sldId id="291" r:id="rId9"/>
    <p:sldId id="292" r:id="rId10"/>
    <p:sldId id="298" r:id="rId11"/>
    <p:sldId id="300" r:id="rId1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752" y="-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notesMaster" Target="notesMasters/notesMaster1.xml"/><Relationship Id="rId14" Type="http://schemas.openxmlformats.org/officeDocument/2006/relationships/printerSettings" Target="printerSettings/printerSettings1.bin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EA8969-ECE0-4D74-AEBC-132016491B64}" type="datetimeFigureOut">
              <a:rPr lang="en-US" smtClean="0"/>
              <a:t>1/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51B6CD-5B7B-4B86-9C8B-4AC319589B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7392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sum of abundances of sequences matching to all new cassava miRNAs identified in this study. Precursors are plotted against their locations and the overall sRNA distribution within a 3kb vicinity in the genomic chunk. The most abundant sequence is denoted with a red arrow; other sRNAs of different sizes are also shown. </a:t>
            </a:r>
            <a:r>
              <a:rPr lang="en-US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ome miRNAs were mapped to loci with high levels of sRNAs as well as to loci with low levels of sRNAs.</a:t>
            </a:r>
            <a:r>
              <a:rPr lang="en-US" smtClean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51B6CD-5B7B-4B86-9C8B-4AC319589BC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469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50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870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930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926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71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387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958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839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08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688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864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EF824-4667-4612-9F39-9C6F012706D9}" type="datetimeFigureOut">
              <a:rPr lang="en-US" smtClean="0"/>
              <a:t>1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518F2A-0A73-4FE0-AF96-38D6BB864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898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1.png"/><Relationship Id="rId3" Type="http://schemas.openxmlformats.org/officeDocument/2006/relationships/image" Target="../media/image2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png"/><Relationship Id="rId3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png"/><Relationship Id="rId3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png"/><Relationship Id="rId3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2.png"/><Relationship Id="rId3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4.png"/><Relationship Id="rId3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6.png"/><Relationship Id="rId3" Type="http://schemas.openxmlformats.org/officeDocument/2006/relationships/image" Target="../media/image1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3823927"/>
              </p:ext>
            </p:extLst>
          </p:nvPr>
        </p:nvGraphicFramePr>
        <p:xfrm>
          <a:off x="4807" y="189563"/>
          <a:ext cx="6700793" cy="49623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75810"/>
                <a:gridCol w="3596183"/>
                <a:gridCol w="685800"/>
                <a:gridCol w="1143000"/>
              </a:tblGrid>
              <a:tr h="236092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50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171l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CGAGCCGAACCAAUAUCACUC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1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1854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1295400" y="7620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7730</a:t>
            </a:r>
            <a:endParaRPr lang="en-US" dirty="0">
              <a:solidFill>
                <a:srgbClr val="000000"/>
              </a:solidFill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1071181"/>
              </p:ext>
            </p:extLst>
          </p:nvPr>
        </p:nvGraphicFramePr>
        <p:xfrm>
          <a:off x="0" y="3840514"/>
          <a:ext cx="6629400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7531"/>
                <a:gridCol w="3506869"/>
                <a:gridCol w="838200"/>
                <a:gridCol w="1066800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err="1">
                          <a:effectLst/>
                          <a:latin typeface="Arial"/>
                          <a:cs typeface="Arial"/>
                        </a:rPr>
                        <a:t>precursor_id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211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GUUCCCAUGCCACCCAUUUCUA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1443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295400" y="44196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8359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1143000"/>
            <a:ext cx="4318000" cy="24384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5400" y="4724400"/>
            <a:ext cx="43434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7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5820512"/>
              </p:ext>
            </p:extLst>
          </p:nvPr>
        </p:nvGraphicFramePr>
        <p:xfrm>
          <a:off x="1" y="152400"/>
          <a:ext cx="6629399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60381"/>
                <a:gridCol w="3640218"/>
                <a:gridCol w="838200"/>
                <a:gridCol w="990600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399h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GGGCACCUCUCGCUUGGCAGG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1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395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1219200" y="762000"/>
            <a:ext cx="1599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/>
              <a:t>11425-529,458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1295400" y="3733800"/>
            <a:ext cx="1599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11425-531,803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1143000"/>
            <a:ext cx="4318000" cy="2438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5400" y="4038600"/>
            <a:ext cx="43180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7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4959169"/>
              </p:ext>
            </p:extLst>
          </p:nvPr>
        </p:nvGraphicFramePr>
        <p:xfrm>
          <a:off x="324338" y="5887284"/>
          <a:ext cx="6553200" cy="5946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47800"/>
                <a:gridCol w="3276600"/>
                <a:gridCol w="838200"/>
                <a:gridCol w="990600"/>
              </a:tblGrid>
              <a:tr h="33827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1189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UGUCAUCUCAACCUUGUGUC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1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38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219200" y="64008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9889</a:t>
            </a:r>
            <a:endParaRPr lang="en-US" dirty="0">
              <a:solidFill>
                <a:srgbClr val="000000"/>
              </a:solidFill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0246494"/>
              </p:ext>
            </p:extLst>
          </p:nvPr>
        </p:nvGraphicFramePr>
        <p:xfrm>
          <a:off x="0" y="0"/>
          <a:ext cx="6629399" cy="57269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7531"/>
                <a:gridCol w="3659268"/>
                <a:gridCol w="685800"/>
                <a:gridCol w="1066800"/>
              </a:tblGrid>
              <a:tr h="321251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1189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CAUAAAUUGAACUAUAGACC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0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386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219200" y="4572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1045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168400" y="31242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7778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200" y="762000"/>
            <a:ext cx="4318000" cy="24384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4600" y="3429000"/>
            <a:ext cx="4318000" cy="24384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19200" y="6705600"/>
            <a:ext cx="43434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7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2907208"/>
              </p:ext>
            </p:extLst>
          </p:nvPr>
        </p:nvGraphicFramePr>
        <p:xfrm>
          <a:off x="0" y="-76200"/>
          <a:ext cx="6858000" cy="68787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87061"/>
                <a:gridCol w="3337339"/>
                <a:gridCol w="796532"/>
                <a:gridCol w="1337068"/>
              </a:tblGrid>
              <a:tr h="239096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4467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938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UUGCAGUUCGAAAGUGGAAGC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640035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314939" y="607524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2373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4" name="AutoShape 2" descr="Gene map"/>
          <p:cNvSpPr>
            <a:spLocks noChangeAspect="1" noChangeArrowheads="1"/>
          </p:cNvSpPr>
          <p:nvPr/>
        </p:nvSpPr>
        <p:spPr bwMode="auto">
          <a:xfrm>
            <a:off x="47625" y="-182033"/>
            <a:ext cx="228600" cy="40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" name="AutoShape 4" descr="Gene map"/>
          <p:cNvSpPr>
            <a:spLocks noChangeAspect="1" noChangeArrowheads="1"/>
          </p:cNvSpPr>
          <p:nvPr/>
        </p:nvSpPr>
        <p:spPr bwMode="auto">
          <a:xfrm>
            <a:off x="161925" y="21167"/>
            <a:ext cx="228600" cy="40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" name="AutoShape 6" descr="Gene map"/>
          <p:cNvSpPr>
            <a:spLocks noChangeAspect="1" noChangeArrowheads="1"/>
          </p:cNvSpPr>
          <p:nvPr/>
        </p:nvSpPr>
        <p:spPr bwMode="auto">
          <a:xfrm>
            <a:off x="276225" y="224367"/>
            <a:ext cx="228600" cy="40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1314939" y="6257992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3209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238738" y="3516868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6158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4938" y="6553200"/>
            <a:ext cx="4318000" cy="24384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5887" y="3810000"/>
            <a:ext cx="4318000" cy="24384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20800" y="900656"/>
            <a:ext cx="43180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72986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708531"/>
              </p:ext>
            </p:extLst>
          </p:nvPr>
        </p:nvGraphicFramePr>
        <p:xfrm>
          <a:off x="0" y="106714"/>
          <a:ext cx="6477000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7531"/>
                <a:gridCol w="3125869"/>
                <a:gridCol w="914400"/>
                <a:gridCol w="1219200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482e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CUUACCUACACCGCCCAUGCC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141313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219200" y="5334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3363</a:t>
            </a:r>
            <a:endParaRPr lang="en-US" dirty="0">
              <a:solidFill>
                <a:srgbClr val="000000"/>
              </a:solidFill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1347208"/>
              </p:ext>
            </p:extLst>
          </p:nvPr>
        </p:nvGraphicFramePr>
        <p:xfrm>
          <a:off x="0" y="3352800"/>
          <a:ext cx="6648450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66850"/>
                <a:gridCol w="3048000"/>
                <a:gridCol w="633221"/>
                <a:gridCol w="1500379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482b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UCCCAAUGUCGCCCAUUCCGA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123159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371600" y="3855686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4043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200" y="826532"/>
            <a:ext cx="4318000" cy="24384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1600" y="4191000"/>
            <a:ext cx="43180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72986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2989055"/>
              </p:ext>
            </p:extLst>
          </p:nvPr>
        </p:nvGraphicFramePr>
        <p:xfrm>
          <a:off x="1" y="0"/>
          <a:ext cx="6629399" cy="5689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49196"/>
                <a:gridCol w="3346603"/>
                <a:gridCol w="838200"/>
                <a:gridCol w="1295400"/>
              </a:tblGrid>
              <a:tr h="28448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844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362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UGUCGCAGGAGCGGUGGCACC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83898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143000" y="5334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3418</a:t>
            </a:r>
            <a:endParaRPr lang="en-US" dirty="0">
              <a:solidFill>
                <a:srgbClr val="000000"/>
              </a:solidFill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0776566"/>
              </p:ext>
            </p:extLst>
          </p:nvPr>
        </p:nvGraphicFramePr>
        <p:xfrm>
          <a:off x="29308" y="3352800"/>
          <a:ext cx="6858000" cy="64778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05000"/>
                <a:gridCol w="3200400"/>
                <a:gridCol w="703729"/>
                <a:gridCol w="1048871"/>
              </a:tblGrid>
              <a:tr h="381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6678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482c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UUUCCCAAGACCUCCCAUACC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78356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143000" y="40386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3650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0" y="838200"/>
            <a:ext cx="4318000" cy="24384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3000" y="4343400"/>
            <a:ext cx="43180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7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8955245"/>
              </p:ext>
            </p:extLst>
          </p:nvPr>
        </p:nvGraphicFramePr>
        <p:xfrm>
          <a:off x="0" y="110347"/>
          <a:ext cx="6705600" cy="55624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05000"/>
                <a:gridCol w="3276600"/>
                <a:gridCol w="533400"/>
                <a:gridCol w="990600"/>
              </a:tblGrid>
              <a:tr h="304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482d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UCCCGACACCACCCAUUCCAU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63034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219200" y="6858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3604</a:t>
            </a:r>
            <a:endParaRPr lang="en-US" b="1" dirty="0">
              <a:solidFill>
                <a:srgbClr val="000000"/>
              </a:solidFill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4233610"/>
              </p:ext>
            </p:extLst>
          </p:nvPr>
        </p:nvGraphicFramePr>
        <p:xfrm>
          <a:off x="9615" y="3505200"/>
          <a:ext cx="6619785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7531"/>
                <a:gridCol w="3497254"/>
                <a:gridCol w="762000"/>
                <a:gridCol w="1143000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535d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UGACGACGAGAGAGAGCACG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1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44468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219200" y="4008086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1190</a:t>
            </a:r>
            <a:endParaRPr lang="en-US" b="1" dirty="0">
              <a:solidFill>
                <a:srgbClr val="000000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200" y="978932"/>
            <a:ext cx="4318000" cy="24384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9200" y="4343400"/>
            <a:ext cx="43180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7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4733303"/>
              </p:ext>
            </p:extLst>
          </p:nvPr>
        </p:nvGraphicFramePr>
        <p:xfrm>
          <a:off x="1" y="126854"/>
          <a:ext cx="6705599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00199"/>
                <a:gridCol w="3124200"/>
                <a:gridCol w="914400"/>
                <a:gridCol w="1066800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477j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CUCUCCCUAAAGGCUUCAAC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1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32998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1295400" y="5334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3851</a:t>
            </a:r>
            <a:endParaRPr lang="en-US" dirty="0">
              <a:solidFill>
                <a:srgbClr val="000000"/>
              </a:solidFill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7948294"/>
              </p:ext>
            </p:extLst>
          </p:nvPr>
        </p:nvGraphicFramePr>
        <p:xfrm>
          <a:off x="0" y="3352800"/>
          <a:ext cx="6629400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7531"/>
                <a:gridCol w="3506869"/>
                <a:gridCol w="762000"/>
                <a:gridCol w="1143000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535d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UGACGACGAGAGAGAGCACA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21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9985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295400" y="39624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 smtClean="0"/>
              <a:t>5782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838200"/>
            <a:ext cx="4318000" cy="24384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1600" y="4267200"/>
            <a:ext cx="43180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7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4177725"/>
              </p:ext>
            </p:extLst>
          </p:nvPr>
        </p:nvGraphicFramePr>
        <p:xfrm>
          <a:off x="0" y="182914"/>
          <a:ext cx="6705599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43019"/>
                <a:gridCol w="3433781"/>
                <a:gridCol w="838200"/>
                <a:gridCol w="990599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1446b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GAACUCUCCCCCUCAACGGCU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50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252357" y="7620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1701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1295400" y="35052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9876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1066800"/>
            <a:ext cx="4318000" cy="24384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5400" y="3886200"/>
            <a:ext cx="43180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7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5058125"/>
              </p:ext>
            </p:extLst>
          </p:nvPr>
        </p:nvGraphicFramePr>
        <p:xfrm>
          <a:off x="3739" y="182914"/>
          <a:ext cx="6625661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7531"/>
                <a:gridCol w="3503130"/>
                <a:gridCol w="838200"/>
                <a:gridCol w="1066800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530b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GCAUUUGCACCUGCACCUUA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21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828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1371600" y="6858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4182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1295400" y="34290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8316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990600"/>
            <a:ext cx="4318000" cy="2438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5400" y="3733800"/>
            <a:ext cx="43180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7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3629795"/>
              </p:ext>
            </p:extLst>
          </p:nvPr>
        </p:nvGraphicFramePr>
        <p:xfrm>
          <a:off x="0" y="-76200"/>
          <a:ext cx="6629400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7531"/>
                <a:gridCol w="3659269"/>
                <a:gridCol w="685800"/>
                <a:gridCol w="1066800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477k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CUCUCCCUCAAGGGCUUCCGG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766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1295400" y="304800"/>
            <a:ext cx="652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6716</a:t>
            </a:r>
            <a:endParaRPr lang="en-US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6132132"/>
              </p:ext>
            </p:extLst>
          </p:nvPr>
        </p:nvGraphicFramePr>
        <p:xfrm>
          <a:off x="0" y="3169886"/>
          <a:ext cx="6629399" cy="502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24000"/>
                <a:gridCol w="3276599"/>
                <a:gridCol w="838200"/>
                <a:gridCol w="990600"/>
              </a:tblGrid>
              <a:tr h="251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Annotation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tag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length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  <a:latin typeface="Arial"/>
                          <a:cs typeface="Arial"/>
                        </a:rPr>
                        <a:t>abundance</a:t>
                      </a:r>
                      <a:endParaRPr lang="en-US" sz="15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  <a:tr h="2514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s-miR169ad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 smtClean="0">
                          <a:effectLst/>
                          <a:latin typeface="Arial"/>
                          <a:cs typeface="Arial"/>
                        </a:rPr>
                        <a:t>UCACAGGCUCUUAUUUUUCAUG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2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  <a:latin typeface="Arial"/>
                          <a:cs typeface="Arial"/>
                        </a:rPr>
                        <a:t>586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72" marR="7072" marT="12572" marB="0" anchor="b"/>
                </a:tc>
              </a:tr>
            </a:tbl>
          </a:graphicData>
        </a:graphic>
      </p:graphicFrame>
      <p:sp>
        <p:nvSpPr>
          <p:cNvPr id="8" name="Rectangle 7"/>
          <p:cNvSpPr/>
          <p:nvPr/>
        </p:nvSpPr>
        <p:spPr>
          <a:xfrm>
            <a:off x="1295400" y="6400800"/>
            <a:ext cx="13658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5005-24,221</a:t>
            </a:r>
          </a:p>
        </p:txBody>
      </p:sp>
      <p:sp>
        <p:nvSpPr>
          <p:cNvPr id="10" name="Rectangle 9"/>
          <p:cNvSpPr/>
          <p:nvPr/>
        </p:nvSpPr>
        <p:spPr>
          <a:xfrm>
            <a:off x="1295400" y="3581400"/>
            <a:ext cx="12490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5005-7,398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609600"/>
            <a:ext cx="4318000" cy="2438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5400" y="3962400"/>
            <a:ext cx="4318000" cy="24384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5400" y="6705600"/>
            <a:ext cx="43180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7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8</TotalTime>
  <Words>298</Words>
  <Application>Microsoft Macintosh PowerPoint</Application>
  <PresentationFormat>On-screen Show (4:3)</PresentationFormat>
  <Paragraphs>171</Paragraphs>
  <Slides>1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laware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hnam Khatabibavilolyaei</dc:creator>
  <cp:lastModifiedBy>vincent fondong</cp:lastModifiedBy>
  <cp:revision>79</cp:revision>
  <dcterms:created xsi:type="dcterms:W3CDTF">2014-05-08T16:10:49Z</dcterms:created>
  <dcterms:modified xsi:type="dcterms:W3CDTF">2016-01-01T10:18:54Z</dcterms:modified>
</cp:coreProperties>
</file>